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19.png" ContentType="image/png"/>
  <Override PartName="/ppt/media/image1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</p:sldIdLst>
  <p:sldSz cx="9158288" cy="91582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714320" y="685440"/>
            <a:ext cx="3429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90BD44-085D-42CE-9132-FF57056CE088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sldImg"/>
          </p:nvPr>
        </p:nvSpPr>
        <p:spPr>
          <a:xfrm>
            <a:off x="1714680" y="685800"/>
            <a:ext cx="3429000" cy="3429000"/>
          </a:xfrm>
          <a:prstGeom prst="rect">
            <a:avLst/>
          </a:prstGeom>
          <a:ln w="0">
            <a:noFill/>
          </a:ln>
        </p:spPr>
      </p:sp>
      <p:sp>
        <p:nvSpPr>
          <p:cNvPr id="10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General paramete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5409C2-1A09-42B6-AAE8-2CBBDEFDD878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sldImg"/>
          </p:nvPr>
        </p:nvSpPr>
        <p:spPr>
          <a:xfrm>
            <a:off x="1714680" y="685800"/>
            <a:ext cx="3429000" cy="3429000"/>
          </a:xfrm>
          <a:prstGeom prst="rect">
            <a:avLst/>
          </a:prstGeom>
          <a:ln w="0">
            <a:noFill/>
          </a:ln>
        </p:spPr>
      </p:sp>
      <p:sp>
        <p:nvSpPr>
          <p:cNvPr id="11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Two-set specific paramete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B90B60-AF3A-4937-BD17-93C8ED8B3087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sldImg"/>
          </p:nvPr>
        </p:nvSpPr>
        <p:spPr>
          <a:xfrm>
            <a:off x="1714680" y="685800"/>
            <a:ext cx="3429000" cy="3429000"/>
          </a:xfrm>
          <a:prstGeom prst="rect">
            <a:avLst/>
          </a:prstGeom>
          <a:ln w="0">
            <a:noFill/>
          </a:ln>
        </p:spPr>
      </p:sp>
      <p:sp>
        <p:nvSpPr>
          <p:cNvPr id="11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Three-set rotations/reversio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989D79-A48D-47AE-B333-A07AD219D1CB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sldImg"/>
          </p:nvPr>
        </p:nvSpPr>
        <p:spPr>
          <a:xfrm>
            <a:off x="1714680" y="685800"/>
            <a:ext cx="3429000" cy="3429000"/>
          </a:xfrm>
          <a:prstGeom prst="rect">
            <a:avLst/>
          </a:prstGeom>
          <a:ln w="0">
            <a:noFill/>
          </a:ln>
        </p:spPr>
      </p:sp>
      <p:sp>
        <p:nvSpPr>
          <p:cNvPr id="11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Enable Euler diagram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4F069C-D4A8-41C7-8C0D-92E584A0ADAA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sldImg"/>
          </p:nvPr>
        </p:nvSpPr>
        <p:spPr>
          <a:xfrm>
            <a:off x="1714680" y="685800"/>
            <a:ext cx="3429000" cy="3429000"/>
          </a:xfrm>
          <a:prstGeom prst="rect">
            <a:avLst/>
          </a:prstGeom>
          <a:ln w="0">
            <a:noFill/>
          </a:ln>
        </p:spPr>
      </p:sp>
      <p:sp>
        <p:nvSpPr>
          <p:cNvPr id="11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Rot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1C0AB8-BE15-4516-A327-CACE9FBE3DD0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sldImg"/>
          </p:nvPr>
        </p:nvSpPr>
        <p:spPr>
          <a:xfrm>
            <a:off x="1714680" y="685800"/>
            <a:ext cx="3429000" cy="3429000"/>
          </a:xfrm>
          <a:prstGeom prst="rect">
            <a:avLst/>
          </a:prstGeom>
          <a:ln w="0">
            <a:noFill/>
          </a:ln>
        </p:spPr>
      </p:sp>
      <p:sp>
        <p:nvSpPr>
          <p:cNvPr id="12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Usage and relation between the “euler.d” and “scaled” arguments (also applicable to certain three-set case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10107F-12EF-4125-A7F6-4E1D526E27AE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C68496-D95C-4771-9D19-A52BDD5D41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6840" y="366480"/>
            <a:ext cx="8242200" cy="1525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6840" y="2136600"/>
            <a:ext cx="824220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6840" y="5292720"/>
            <a:ext cx="824220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D15A7-587D-4249-AA8D-F66F9A5D45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6840" y="366480"/>
            <a:ext cx="8242200" cy="1525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6840" y="2136600"/>
            <a:ext cx="4021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80360" y="2136600"/>
            <a:ext cx="4021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6840" y="5292720"/>
            <a:ext cx="4021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80360" y="5292720"/>
            <a:ext cx="4021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0D345-23A7-4DA9-AC69-BBBB19F39F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6840" y="366480"/>
            <a:ext cx="8242200" cy="1525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6840" y="2136600"/>
            <a:ext cx="2653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43960" y="2136600"/>
            <a:ext cx="2653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30720" y="2136600"/>
            <a:ext cx="2653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6840" y="5292720"/>
            <a:ext cx="2653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43960" y="5292720"/>
            <a:ext cx="2653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30720" y="5292720"/>
            <a:ext cx="2653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A92E11-CDB5-4D57-9A8B-FB0B6B2282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6840" y="366480"/>
            <a:ext cx="8242200" cy="1525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6840" y="2136600"/>
            <a:ext cx="8242200" cy="6042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25652F-1687-48AA-B08C-1A04A8AA6A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6840" y="366480"/>
            <a:ext cx="8242200" cy="1525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6840" y="2136600"/>
            <a:ext cx="8242200" cy="6042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519EBA-201F-47CE-A2DD-033EE4E3E9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6840" y="366480"/>
            <a:ext cx="8242200" cy="1525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6840" y="2136600"/>
            <a:ext cx="4021920" cy="6042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80360" y="2136600"/>
            <a:ext cx="4021920" cy="6042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4645EA-E8E5-4E0A-A455-39C05AC1ED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6840" y="366480"/>
            <a:ext cx="8242200" cy="1525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0361C-C63E-4B38-926D-D1F148632C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6840" y="366480"/>
            <a:ext cx="8242200" cy="707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9C4489-E585-4017-B24A-7B23395C48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6840" y="366480"/>
            <a:ext cx="8242200" cy="1525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6840" y="2136600"/>
            <a:ext cx="4021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80360" y="2136600"/>
            <a:ext cx="4021920" cy="6042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6840" y="5292720"/>
            <a:ext cx="4021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44268-99C1-4079-8591-98BE2D5ADD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6840" y="366480"/>
            <a:ext cx="8242200" cy="1525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6840" y="2136600"/>
            <a:ext cx="4021920" cy="6042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80360" y="2136600"/>
            <a:ext cx="4021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80360" y="5292720"/>
            <a:ext cx="4021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8A16A-C3CB-4DFB-836C-6BE517C729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6840" y="366480"/>
            <a:ext cx="8242200" cy="1525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6840" y="2136600"/>
            <a:ext cx="4021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80360" y="2136600"/>
            <a:ext cx="402192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6840" y="5292720"/>
            <a:ext cx="8242200" cy="288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F9C21B-28CA-4BB4-8B82-612D1BCA97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6840" y="366480"/>
            <a:ext cx="8242200" cy="1525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6840" y="2136600"/>
            <a:ext cx="8242200" cy="6042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164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884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884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884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8486640"/>
            <a:ext cx="2136600" cy="4874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9120" y="8486640"/>
            <a:ext cx="2898720" cy="4874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62440" y="8486640"/>
            <a:ext cx="2136600" cy="4874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250F36-2DEE-4F9F-ADA9-5B4BEBECBC3D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image" Target="../media/image17.png"/><Relationship Id="rId10" Type="http://schemas.openxmlformats.org/officeDocument/2006/relationships/image" Target="../media/image17.png"/><Relationship Id="rId11" Type="http://schemas.openxmlformats.org/officeDocument/2006/relationships/image" Target="../media/image18.png"/><Relationship Id="rId12" Type="http://schemas.openxmlformats.org/officeDocument/2006/relationships/image" Target="../media/image19.pn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6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C:\Hanbert\data\Venn Diagram\parameter examples\Single-set Venn Diagram.tiff"/>
          <p:cNvPicPr/>
          <p:nvPr/>
        </p:nvPicPr>
        <p:blipFill>
          <a:blip r:embed="rId1"/>
          <a:stretch/>
        </p:blipFill>
        <p:spPr>
          <a:xfrm>
            <a:off x="0" y="0"/>
            <a:ext cx="9167760" cy="9166320"/>
          </a:xfrm>
          <a:prstGeom prst="rect">
            <a:avLst/>
          </a:prstGeom>
          <a:ln w="0">
            <a:noFill/>
          </a:ln>
        </p:spPr>
      </p:pic>
      <p:sp>
        <p:nvSpPr>
          <p:cNvPr id="49" name="TextBox 5"/>
          <p:cNvSpPr/>
          <p:nvPr/>
        </p:nvSpPr>
        <p:spPr>
          <a:xfrm>
            <a:off x="6864480" y="863640"/>
            <a:ext cx="1928520" cy="916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col = "blue"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lwd =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lty = "dashed"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8"/>
          <p:cNvSpPr/>
          <p:nvPr/>
        </p:nvSpPr>
        <p:spPr>
          <a:xfrm>
            <a:off x="6649920" y="7013520"/>
            <a:ext cx="1928880" cy="642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fill = "light blue"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alpha = 0.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2"/>
          <p:cNvSpPr/>
          <p:nvPr/>
        </p:nvSpPr>
        <p:spPr>
          <a:xfrm>
            <a:off x="571680" y="7013520"/>
            <a:ext cx="2077920" cy="1191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label.col = "white"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cex =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fontface = "italic"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fontfamily = "arial"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25"/>
          <p:cNvSpPr/>
          <p:nvPr/>
        </p:nvSpPr>
        <p:spPr>
          <a:xfrm>
            <a:off x="220680" y="291960"/>
            <a:ext cx="2500200" cy="228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cat.pos = -20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cat.dist = 0.0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cat.cex = 1.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cat.col = "black"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cat.fontface = "italic"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cat.fontfamily = "arial"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cat.default.pos = "outer“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cat.just = list(c(0.5, 0.5)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31"/>
          <p:cNvSpPr/>
          <p:nvPr/>
        </p:nvSpPr>
        <p:spPr>
          <a:xfrm>
            <a:off x="4649760" y="577800"/>
            <a:ext cx="150012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margin = 0.1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4" name="Straight Arrow Connector 39"/>
          <p:cNvCxnSpPr/>
          <p:nvPr/>
        </p:nvCxnSpPr>
        <p:spPr>
          <a:xfrm flipV="1">
            <a:off x="5362920" y="720"/>
            <a:ext cx="2520" cy="505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5" name="Straight Arrow Connector 41"/>
          <p:cNvCxnSpPr/>
          <p:nvPr/>
        </p:nvCxnSpPr>
        <p:spPr>
          <a:xfrm flipH="1">
            <a:off x="5363280" y="1006560"/>
            <a:ext cx="2520" cy="714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6" name="Straight Connector 43"/>
          <p:cNvSpPr/>
          <p:nvPr/>
        </p:nvSpPr>
        <p:spPr>
          <a:xfrm>
            <a:off x="3776760" y="1720800"/>
            <a:ext cx="2944800" cy="0"/>
          </a:xfrm>
          <a:prstGeom prst="line">
            <a:avLst/>
          </a:prstGeom>
          <a:ln w="9360">
            <a:solidFill>
              <a:srgbClr val="000000">
                <a:alpha val="47000"/>
              </a:srgbClr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7" name="Straight Arrow Connector 45"/>
          <p:cNvCxnSpPr>
            <a:stCxn id="49" idx="2"/>
          </p:cNvCxnSpPr>
          <p:nvPr/>
        </p:nvCxnSpPr>
        <p:spPr>
          <a:xfrm flipH="1">
            <a:off x="6364080" y="1780560"/>
            <a:ext cx="1464840" cy="1226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8" name="Straight Arrow Connector 47"/>
          <p:cNvCxnSpPr>
            <a:stCxn id="50" idx="0"/>
          </p:cNvCxnSpPr>
          <p:nvPr/>
        </p:nvCxnSpPr>
        <p:spPr>
          <a:xfrm flipH="1" flipV="1">
            <a:off x="5934960" y="5935680"/>
            <a:ext cx="1679760" cy="10782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9" name="Straight Arrow Connector 49"/>
          <p:cNvCxnSpPr>
            <a:stCxn id="51" idx="0"/>
          </p:cNvCxnSpPr>
          <p:nvPr/>
        </p:nvCxnSpPr>
        <p:spPr>
          <a:xfrm flipV="1">
            <a:off x="1610640" y="5221080"/>
            <a:ext cx="2896920" cy="1792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0" name="Straight Arrow Connector 51"/>
          <p:cNvCxnSpPr>
            <a:stCxn id="52" idx="3"/>
          </p:cNvCxnSpPr>
          <p:nvPr/>
        </p:nvCxnSpPr>
        <p:spPr>
          <a:xfrm>
            <a:off x="2720880" y="1436040"/>
            <a:ext cx="357840" cy="285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4" descr="C:\Hanbert\data\Venn Diagram\parameter examples\Two-set Venn Diagram ext.line2.tiff"/>
          <p:cNvPicPr/>
          <p:nvPr/>
        </p:nvPicPr>
        <p:blipFill>
          <a:blip r:embed="rId1"/>
          <a:stretch/>
        </p:blipFill>
        <p:spPr>
          <a:xfrm>
            <a:off x="4116240" y="4116240"/>
            <a:ext cx="5040360" cy="504036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2" descr="C:\Hanbert\data\Venn Diagram\parameter examples\Two-set Venn Diagram ext.line.tiff"/>
          <p:cNvPicPr/>
          <p:nvPr/>
        </p:nvPicPr>
        <p:blipFill>
          <a:blip r:embed="rId2"/>
          <a:stretch/>
        </p:blipFill>
        <p:spPr>
          <a:xfrm>
            <a:off x="165240" y="0"/>
            <a:ext cx="5040000" cy="5040360"/>
          </a:xfrm>
          <a:prstGeom prst="rect">
            <a:avLst/>
          </a:prstGeom>
          <a:ln w="0">
            <a:noFill/>
          </a:ln>
        </p:spPr>
      </p:pic>
      <p:sp>
        <p:nvSpPr>
          <p:cNvPr id="63" name="TextBox 3"/>
          <p:cNvSpPr/>
          <p:nvPr/>
        </p:nvSpPr>
        <p:spPr>
          <a:xfrm>
            <a:off x="4006800" y="220680"/>
            <a:ext cx="1928880" cy="1465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xt.text = TR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xt.line.lwd =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xt.dist = 0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xt.l =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xt.pos = 0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4"/>
          <p:cNvSpPr/>
          <p:nvPr/>
        </p:nvSpPr>
        <p:spPr>
          <a:xfrm>
            <a:off x="6507000" y="2720880"/>
            <a:ext cx="1928880" cy="1465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xt.text = TR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xt.line.lwd =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xt.dist = -0.1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xt.l = 0.9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xt.pos = -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5" name="Straight Arrow Connector 10"/>
          <p:cNvCxnSpPr>
            <a:stCxn id="63" idx="1"/>
          </p:cNvCxnSpPr>
          <p:nvPr/>
        </p:nvCxnSpPr>
        <p:spPr>
          <a:xfrm flipH="1">
            <a:off x="3292200" y="957600"/>
            <a:ext cx="714960" cy="334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6" name="TextBox 13"/>
          <p:cNvSpPr/>
          <p:nvPr/>
        </p:nvSpPr>
        <p:spPr>
          <a:xfrm>
            <a:off x="792000" y="4792680"/>
            <a:ext cx="1857600" cy="642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scaled = TR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inverted = FAL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14"/>
          <p:cNvSpPr/>
          <p:nvPr/>
        </p:nvSpPr>
        <p:spPr>
          <a:xfrm>
            <a:off x="4506840" y="8078760"/>
            <a:ext cx="1857600" cy="642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scaled = TR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inverted =TR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8" name="Straight Arrow Connector 12"/>
          <p:cNvCxnSpPr>
            <a:stCxn id="64" idx="2"/>
          </p:cNvCxnSpPr>
          <p:nvPr/>
        </p:nvCxnSpPr>
        <p:spPr>
          <a:xfrm flipH="1">
            <a:off x="6149520" y="4199040"/>
            <a:ext cx="1323360" cy="1094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9" name="Straight Connector 18"/>
          <p:cNvSpPr/>
          <p:nvPr/>
        </p:nvSpPr>
        <p:spPr>
          <a:xfrm flipH="1">
            <a:off x="-360" y="0"/>
            <a:ext cx="9156600" cy="9156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2" descr="C:\Hanbert\data\Venn Diagram\parameter examples\Three-set Venn Diagram 1.tiff"/>
          <p:cNvPicPr/>
          <p:nvPr/>
        </p:nvPicPr>
        <p:blipFill>
          <a:blip r:embed="rId1"/>
          <a:stretch/>
        </p:blipFill>
        <p:spPr>
          <a:xfrm>
            <a:off x="4476600" y="4476600"/>
            <a:ext cx="4680000" cy="468000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3" descr="C:\Hanbert\data\Venn Diagram\parameter examples\Three-set Venn Diagram reverse.tiff"/>
          <p:cNvPicPr/>
          <p:nvPr/>
        </p:nvPicPr>
        <p:blipFill>
          <a:blip r:embed="rId2"/>
          <a:stretch/>
        </p:blipFill>
        <p:spPr>
          <a:xfrm>
            <a:off x="291960" y="0"/>
            <a:ext cx="4680000" cy="4680000"/>
          </a:xfrm>
          <a:prstGeom prst="rect">
            <a:avLst/>
          </a:prstGeom>
          <a:ln w="0">
            <a:noFill/>
          </a:ln>
        </p:spPr>
      </p:pic>
      <p:sp>
        <p:nvSpPr>
          <p:cNvPr id="72" name="Straight Connector 4"/>
          <p:cNvSpPr/>
          <p:nvPr/>
        </p:nvSpPr>
        <p:spPr>
          <a:xfrm flipH="1">
            <a:off x="-360" y="0"/>
            <a:ext cx="9156600" cy="9156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6"/>
          <p:cNvSpPr/>
          <p:nvPr/>
        </p:nvSpPr>
        <p:spPr>
          <a:xfrm>
            <a:off x="363600" y="4792680"/>
            <a:ext cx="1714320" cy="642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rotation =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reverse = FAL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7"/>
          <p:cNvSpPr/>
          <p:nvPr/>
        </p:nvSpPr>
        <p:spPr>
          <a:xfrm>
            <a:off x="6792840" y="3506760"/>
            <a:ext cx="1714680" cy="642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rotation =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reverse = TR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Picture 2" descr="C:\Hanbert\data\Venn Diagram\parameter examples\Triple special case diabled.tiff"/>
          <p:cNvPicPr/>
          <p:nvPr/>
        </p:nvPicPr>
        <p:blipFill>
          <a:blip r:embed="rId1"/>
          <a:stretch/>
        </p:blipFill>
        <p:spPr>
          <a:xfrm>
            <a:off x="0" y="0"/>
            <a:ext cx="5486400" cy="548640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3" descr="C:\Hanbert\data\Venn Diagram\parameter examples\Triple special case enabled.tiff"/>
          <p:cNvPicPr/>
          <p:nvPr/>
        </p:nvPicPr>
        <p:blipFill>
          <a:blip r:embed="rId2"/>
          <a:srcRect l="0" t="10039" r="0" b="0"/>
          <a:stretch/>
        </p:blipFill>
        <p:spPr>
          <a:xfrm>
            <a:off x="3649680" y="4202280"/>
            <a:ext cx="5506920" cy="4954320"/>
          </a:xfrm>
          <a:prstGeom prst="rect">
            <a:avLst/>
          </a:prstGeom>
          <a:ln w="0">
            <a:noFill/>
          </a:ln>
        </p:spPr>
      </p:pic>
      <p:sp>
        <p:nvSpPr>
          <p:cNvPr id="77" name="TextBox 3"/>
          <p:cNvSpPr/>
          <p:nvPr/>
        </p:nvSpPr>
        <p:spPr>
          <a:xfrm>
            <a:off x="5292720" y="577800"/>
            <a:ext cx="186372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uler.d = FAL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4"/>
          <p:cNvSpPr/>
          <p:nvPr/>
        </p:nvSpPr>
        <p:spPr>
          <a:xfrm>
            <a:off x="6864480" y="8507520"/>
            <a:ext cx="186372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euler.d = TR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Straight Connector 6"/>
          <p:cNvSpPr/>
          <p:nvPr/>
        </p:nvSpPr>
        <p:spPr>
          <a:xfrm flipH="1">
            <a:off x="-360" y="0"/>
            <a:ext cx="9156600" cy="9156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Picture 2" descr="C:\Hanbert\data\Venn Diagram\parameter examples\No rotation.tiff"/>
          <p:cNvPicPr/>
          <p:nvPr/>
        </p:nvPicPr>
        <p:blipFill>
          <a:blip r:embed="rId1"/>
          <a:stretch/>
        </p:blipFill>
        <p:spPr>
          <a:xfrm>
            <a:off x="0" y="0"/>
            <a:ext cx="5486400" cy="548640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3" descr="C:\Hanbert\data\Venn Diagram\parameter examples\Rotation.tiff"/>
          <p:cNvPicPr/>
          <p:nvPr/>
        </p:nvPicPr>
        <p:blipFill>
          <a:blip r:embed="rId2"/>
          <a:stretch/>
        </p:blipFill>
        <p:spPr>
          <a:xfrm>
            <a:off x="3670200" y="3670200"/>
            <a:ext cx="5486400" cy="5486400"/>
          </a:xfrm>
          <a:prstGeom prst="rect">
            <a:avLst/>
          </a:prstGeom>
          <a:ln w="0">
            <a:noFill/>
          </a:ln>
        </p:spPr>
      </p:pic>
      <p:sp>
        <p:nvSpPr>
          <p:cNvPr id="82" name="Straight Connector 4"/>
          <p:cNvSpPr/>
          <p:nvPr/>
        </p:nvSpPr>
        <p:spPr>
          <a:xfrm flipH="1">
            <a:off x="-360" y="0"/>
            <a:ext cx="9156600" cy="9156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5"/>
          <p:cNvSpPr/>
          <p:nvPr/>
        </p:nvSpPr>
        <p:spPr>
          <a:xfrm>
            <a:off x="363600" y="4935600"/>
            <a:ext cx="142884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rotation = 0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6"/>
          <p:cNvSpPr/>
          <p:nvPr/>
        </p:nvSpPr>
        <p:spPr>
          <a:xfrm>
            <a:off x="7292880" y="3149640"/>
            <a:ext cx="142884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Calibri"/>
              </a:rPr>
              <a:t>rotation = 40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Straight Connector 2"/>
          <p:cNvSpPr/>
          <p:nvPr/>
        </p:nvSpPr>
        <p:spPr>
          <a:xfrm>
            <a:off x="0" y="2514600"/>
            <a:ext cx="915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Straight Connector 3"/>
          <p:cNvSpPr/>
          <p:nvPr/>
        </p:nvSpPr>
        <p:spPr>
          <a:xfrm>
            <a:off x="0" y="4800600"/>
            <a:ext cx="915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Straight Connector 4"/>
          <p:cNvSpPr/>
          <p:nvPr/>
        </p:nvSpPr>
        <p:spPr>
          <a:xfrm>
            <a:off x="0" y="7086600"/>
            <a:ext cx="915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Straight Connector 7"/>
          <p:cNvSpPr/>
          <p:nvPr/>
        </p:nvSpPr>
        <p:spPr>
          <a:xfrm>
            <a:off x="3044880" y="0"/>
            <a:ext cx="0" cy="9153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Straight Connector 8"/>
          <p:cNvSpPr/>
          <p:nvPr/>
        </p:nvSpPr>
        <p:spPr>
          <a:xfrm>
            <a:off x="6099120" y="0"/>
            <a:ext cx="0" cy="9153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Straight Connector 9"/>
          <p:cNvSpPr/>
          <p:nvPr/>
        </p:nvSpPr>
        <p:spPr>
          <a:xfrm>
            <a:off x="0" y="320760"/>
            <a:ext cx="915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10"/>
          <p:cNvSpPr/>
          <p:nvPr/>
        </p:nvSpPr>
        <p:spPr>
          <a:xfrm>
            <a:off x="457200" y="0"/>
            <a:ext cx="2446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euler.d = TRUE &amp; scaled = TRU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11"/>
          <p:cNvSpPr/>
          <p:nvPr/>
        </p:nvSpPr>
        <p:spPr>
          <a:xfrm>
            <a:off x="3435480" y="0"/>
            <a:ext cx="2446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euler.d = TRUE &amp; scaled = FALS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12"/>
          <p:cNvSpPr/>
          <p:nvPr/>
        </p:nvSpPr>
        <p:spPr>
          <a:xfrm>
            <a:off x="6435720" y="0"/>
            <a:ext cx="2446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euler.d = FALSE &amp; scaled = FALS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Picture 2" descr="C:\Hanbert\data\Venn Diagram\Parameter Examples\6.1.tiff"/>
          <p:cNvPicPr/>
          <p:nvPr/>
        </p:nvPicPr>
        <p:blipFill>
          <a:blip r:embed="rId1"/>
          <a:stretch/>
        </p:blipFill>
        <p:spPr>
          <a:xfrm>
            <a:off x="457200" y="357120"/>
            <a:ext cx="2103480" cy="210204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3" descr="C:\Hanbert\data\Venn Diagram\Parameter Examples\6.2.tiff"/>
          <p:cNvPicPr/>
          <p:nvPr/>
        </p:nvPicPr>
        <p:blipFill>
          <a:blip r:embed="rId2"/>
          <a:stretch/>
        </p:blipFill>
        <p:spPr>
          <a:xfrm>
            <a:off x="3502080" y="357120"/>
            <a:ext cx="2103480" cy="210204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4" descr="C:\Hanbert\data\Venn Diagram\Parameter Examples\6.3.tiff"/>
          <p:cNvPicPr/>
          <p:nvPr/>
        </p:nvPicPr>
        <p:blipFill>
          <a:blip r:embed="rId3"/>
          <a:stretch/>
        </p:blipFill>
        <p:spPr>
          <a:xfrm>
            <a:off x="6556320" y="357120"/>
            <a:ext cx="2103480" cy="210204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5" descr="C:\Hanbert\data\Venn Diagram\Parameter Examples\6.4.tiff"/>
          <p:cNvPicPr/>
          <p:nvPr/>
        </p:nvPicPr>
        <p:blipFill>
          <a:blip r:embed="rId4"/>
          <a:stretch/>
        </p:blipFill>
        <p:spPr>
          <a:xfrm>
            <a:off x="457200" y="2643120"/>
            <a:ext cx="2103480" cy="210204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6" descr="C:\Hanbert\data\Venn Diagram\Parameter Examples\6.5.tiff"/>
          <p:cNvPicPr/>
          <p:nvPr/>
        </p:nvPicPr>
        <p:blipFill>
          <a:blip r:embed="rId5"/>
          <a:stretch/>
        </p:blipFill>
        <p:spPr>
          <a:xfrm>
            <a:off x="3502080" y="2643120"/>
            <a:ext cx="2103480" cy="2102040"/>
          </a:xfrm>
          <a:prstGeom prst="rect">
            <a:avLst/>
          </a:prstGeom>
          <a:ln w="0">
            <a:noFill/>
          </a:ln>
        </p:spPr>
      </p:pic>
      <p:pic>
        <p:nvPicPr>
          <p:cNvPr id="99" name="Picture 8" descr="C:\Hanbert\data\Venn Diagram\Parameter Examples\6.7.tiff"/>
          <p:cNvPicPr/>
          <p:nvPr/>
        </p:nvPicPr>
        <p:blipFill>
          <a:blip r:embed="rId6"/>
          <a:stretch/>
        </p:blipFill>
        <p:spPr>
          <a:xfrm>
            <a:off x="457200" y="4929120"/>
            <a:ext cx="2103480" cy="210204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9" descr="C:\Hanbert\data\Venn Diagram\Parameter Examples\6.8.tiff"/>
          <p:cNvPicPr/>
          <p:nvPr/>
        </p:nvPicPr>
        <p:blipFill>
          <a:blip r:embed="rId7"/>
          <a:stretch/>
        </p:blipFill>
        <p:spPr>
          <a:xfrm>
            <a:off x="3502080" y="4929120"/>
            <a:ext cx="2103480" cy="2102040"/>
          </a:xfrm>
          <a:prstGeom prst="rect">
            <a:avLst/>
          </a:prstGeom>
          <a:ln w="0">
            <a:noFill/>
          </a:ln>
        </p:spPr>
      </p:pic>
      <p:pic>
        <p:nvPicPr>
          <p:cNvPr id="101" name="Picture 10" descr="C:\Hanbert\data\Venn Diagram\Parameter Examples\6.9.tiff"/>
          <p:cNvPicPr/>
          <p:nvPr/>
        </p:nvPicPr>
        <p:blipFill>
          <a:blip r:embed="rId8"/>
          <a:stretch/>
        </p:blipFill>
        <p:spPr>
          <a:xfrm>
            <a:off x="6556320" y="4929120"/>
            <a:ext cx="2103480" cy="210204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11" descr="C:\Hanbert\data\Venn Diagram\Parameter Examples\6.10.tiff"/>
          <p:cNvPicPr/>
          <p:nvPr/>
        </p:nvPicPr>
        <p:blipFill>
          <a:blip r:embed="rId9"/>
          <a:stretch/>
        </p:blipFill>
        <p:spPr>
          <a:xfrm>
            <a:off x="639720" y="7215120"/>
            <a:ext cx="1920960" cy="191952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12" descr="C:\Hanbert\data\Venn Diagram\Parameter Examples\6.11.tiff"/>
          <p:cNvPicPr/>
          <p:nvPr/>
        </p:nvPicPr>
        <p:blipFill>
          <a:blip r:embed="rId10"/>
          <a:stretch/>
        </p:blipFill>
        <p:spPr>
          <a:xfrm>
            <a:off x="3684600" y="7215120"/>
            <a:ext cx="1920960" cy="191952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13" descr="C:\Hanbert\data\Venn Diagram\Parameter Examples\6.12.tiff"/>
          <p:cNvPicPr/>
          <p:nvPr/>
        </p:nvPicPr>
        <p:blipFill>
          <a:blip r:embed="rId11"/>
          <a:srcRect l="0" t="0" r="0" b="3304"/>
          <a:stretch/>
        </p:blipFill>
        <p:spPr>
          <a:xfrm>
            <a:off x="6556320" y="7122960"/>
            <a:ext cx="2103480" cy="203364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14" descr="C:\Hanbert\data\Venn Diagram\Parameter Examples\6.6.tiff"/>
          <p:cNvPicPr/>
          <p:nvPr/>
        </p:nvPicPr>
        <p:blipFill>
          <a:blip r:embed="rId12"/>
          <a:stretch/>
        </p:blipFill>
        <p:spPr>
          <a:xfrm>
            <a:off x="6556320" y="2643120"/>
            <a:ext cx="2103480" cy="2102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0T15:11:20Z</dcterms:created>
  <dc:creator>Hanbert</dc:creator>
  <dc:description/>
  <dc:language>en-US</dc:language>
  <cp:lastModifiedBy>hchen</cp:lastModifiedBy>
  <dcterms:modified xsi:type="dcterms:W3CDTF">2010-07-12T18:34:12Z</dcterms:modified>
  <cp:revision>20</cp:revision>
  <dc:subject/>
  <dc:title>Slide 1</dc:title>
</cp:coreProperties>
</file>